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wmf" ContentType="image/x-wmf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49DBED-A2E5-40B0-85ED-AE9BEA44A5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DD897E-9DA1-48B2-830B-0508790FB8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865834-8F59-4475-9D74-57050F12B95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F283E0-5B76-461A-BDD3-C6729E29A08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FAA0CE-CF48-45E3-A7DD-B16B1A2762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F5422-A9DC-44CF-A979-9C415CF229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9E17C5-238F-4708-9CDF-223FE466F9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7283E5-C98B-4214-BEEE-DD51170A272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E90AB-05E3-4B4D-BA08-5F496FB0967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05825B-A925-4C3C-A490-4FAE65A6C8A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05DFAD-0234-48AA-BAF6-804A5537305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A88F9-D932-481A-8B1C-C21886445E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굴림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굴림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굴림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굴림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굴림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굴림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굴림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6185747-8EEB-4185-8D06-72A9091399AD}" type="slidenum">
              <a:rPr b="0" lang="en-US" sz="1400" spc="-1" strike="noStrike">
                <a:solidFill>
                  <a:srgbClr val="000000"/>
                </a:solidFill>
                <a:latin typeface="굴림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oleObject" Target="../embeddings/oleObject2.bin"/><Relationship Id="rId8" Type="http://schemas.openxmlformats.org/officeDocument/2006/relationships/image" Target="../media/image6.wmf"/><Relationship Id="rId9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0" y="276120"/>
          <a:ext cx="4643280" cy="36925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0" y="276120"/>
                    <a:ext cx="4643280" cy="3692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pSp>
        <p:nvGrpSpPr>
          <p:cNvPr id="43" name=""/>
          <p:cNvGrpSpPr/>
          <p:nvPr/>
        </p:nvGrpSpPr>
        <p:grpSpPr>
          <a:xfrm>
            <a:off x="250920" y="3933720"/>
            <a:ext cx="7993080" cy="2024280"/>
            <a:chOff x="250920" y="3933720"/>
            <a:chExt cx="7993080" cy="2024280"/>
          </a:xfrm>
        </p:grpSpPr>
        <p:sp>
          <p:nvSpPr>
            <p:cNvPr id="44" name=""/>
            <p:cNvSpPr/>
            <p:nvPr/>
          </p:nvSpPr>
          <p:spPr>
            <a:xfrm>
              <a:off x="539640" y="5157720"/>
              <a:ext cx="51588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WE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539640" y="5551560"/>
              <a:ext cx="68256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Y229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414440" y="4664160"/>
              <a:ext cx="189396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414440" y="5880240"/>
              <a:ext cx="189396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414440" y="5121360"/>
              <a:ext cx="1893960" cy="0"/>
            </a:xfrm>
            <a:prstGeom prst="line">
              <a:avLst/>
            </a:prstGeom>
            <a:ln w="1908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49" name="" descr=""/>
            <p:cNvPicPr/>
            <p:nvPr/>
          </p:nvPicPr>
          <p:blipFill>
            <a:blip r:embed="rId3"/>
            <a:stretch/>
          </p:blipFill>
          <p:spPr>
            <a:xfrm>
              <a:off x="1415880" y="4286160"/>
              <a:ext cx="1965600" cy="7938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" descr=""/>
            <p:cNvPicPr/>
            <p:nvPr/>
          </p:nvPicPr>
          <p:blipFill>
            <a:blip r:embed="rId4"/>
            <a:stretch/>
          </p:blipFill>
          <p:spPr>
            <a:xfrm>
              <a:off x="1413000" y="5111640"/>
              <a:ext cx="1965240" cy="846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1" name=""/>
            <p:cNvSpPr/>
            <p:nvPr/>
          </p:nvSpPr>
          <p:spPr>
            <a:xfrm>
              <a:off x="395280" y="4316400"/>
              <a:ext cx="103680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ko-KR" sz="1400" spc="-1" strike="noStrike">
                  <a:solidFill>
                    <a:srgbClr val="000000"/>
                  </a:solidFill>
                  <a:latin typeface="Times New Roman"/>
                </a:rPr>
                <a:t>WE</a:t>
              </a:r>
              <a:r>
                <a:rPr b="1" lang="el-GR" sz="1400" spc="-1" strike="noStrike">
                  <a:solidFill>
                    <a:srgbClr val="000000"/>
                  </a:solidFill>
                  <a:latin typeface="Times New Roman"/>
                </a:rPr>
                <a:t>Δ</a:t>
              </a:r>
              <a:r>
                <a:rPr b="1" i="1" lang="ko-KR" sz="1400" spc="-1" strike="noStrike">
                  <a:solidFill>
                    <a:srgbClr val="000000"/>
                  </a:solidFill>
                  <a:latin typeface="Times New Roman"/>
                </a:rPr>
                <a:t>dnaK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50920" y="4772160"/>
              <a:ext cx="1149120" cy="27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ko-KR" sz="1400" spc="-1" strike="noStrike">
                  <a:solidFill>
                    <a:srgbClr val="000000"/>
                  </a:solidFill>
                  <a:latin typeface="Times New Roman"/>
                </a:rPr>
                <a:t>Y229</a:t>
              </a:r>
              <a:r>
                <a:rPr b="1" lang="el-GR" sz="1400" spc="-1" strike="noStrike">
                  <a:solidFill>
                    <a:srgbClr val="000000"/>
                  </a:solidFill>
                  <a:latin typeface="Times New Roman"/>
                </a:rPr>
                <a:t>Δ</a:t>
              </a:r>
              <a:r>
                <a:rPr b="1" i="1" lang="ko-KR" sz="1400" spc="-1" strike="noStrike">
                  <a:solidFill>
                    <a:srgbClr val="000000"/>
                  </a:solidFill>
                  <a:latin typeface="Times New Roman"/>
                </a:rPr>
                <a:t>dnaK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1413000" y="3933720"/>
              <a:ext cx="2008080" cy="311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1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  10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2   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3   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4      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5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292720" y="5229360"/>
              <a:ext cx="558720" cy="217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WE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219640" y="5591160"/>
              <a:ext cx="720720" cy="266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Y229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pic>
          <p:nvPicPr>
            <p:cNvPr id="56" name="" descr=""/>
            <p:cNvPicPr/>
            <p:nvPr/>
          </p:nvPicPr>
          <p:blipFill>
            <a:blip r:embed="rId5"/>
            <a:stretch/>
          </p:blipFill>
          <p:spPr>
            <a:xfrm>
              <a:off x="6032520" y="5153040"/>
              <a:ext cx="2066760" cy="7970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" descr=""/>
            <p:cNvPicPr/>
            <p:nvPr/>
          </p:nvPicPr>
          <p:blipFill>
            <a:blip r:embed="rId6"/>
            <a:stretch/>
          </p:blipFill>
          <p:spPr>
            <a:xfrm>
              <a:off x="6032520" y="4294080"/>
              <a:ext cx="2065320" cy="82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8" name=""/>
            <p:cNvSpPr/>
            <p:nvPr/>
          </p:nvSpPr>
          <p:spPr>
            <a:xfrm>
              <a:off x="5219640" y="4365720"/>
              <a:ext cx="936720" cy="293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WE(P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148360" y="4799160"/>
              <a:ext cx="8636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just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Y229(P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)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991120" y="4005360"/>
              <a:ext cx="2252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10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1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   10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2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    10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3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    10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4</a:t>
              </a: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</a:rPr>
                <a:t>  10</a:t>
              </a:r>
              <a:r>
                <a:rPr b="1" lang="en-US" sz="1400" spc="-1" strike="noStrike" baseline="30000">
                  <a:solidFill>
                    <a:srgbClr val="000000"/>
                  </a:solidFill>
                  <a:latin typeface="Times New Roman"/>
                </a:rPr>
                <a:t>-5</a:t>
              </a:r>
              <a:endParaRPr b="0" lang="en-US" sz="1400" spc="-1" strike="noStrike">
                <a:solidFill>
                  <a:srgbClr val="000000"/>
                </a:solidFill>
                <a:latin typeface="굴림"/>
              </a:endParaRPr>
            </a:p>
          </p:txBody>
        </p:sp>
      </p:grpSp>
      <p:graphicFrame>
        <p:nvGraphicFramePr>
          <p:cNvPr id="61" name=""/>
          <p:cNvGraphicFramePr/>
          <p:nvPr/>
        </p:nvGraphicFramePr>
        <p:xfrm>
          <a:off x="4464000" y="260280"/>
          <a:ext cx="4680000" cy="37371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62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4464000" y="260280"/>
                    <a:ext cx="4680000" cy="37371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63" name=""/>
          <p:cNvSpPr/>
          <p:nvPr/>
        </p:nvSpPr>
        <p:spPr>
          <a:xfrm>
            <a:off x="403560" y="6093000"/>
            <a:ext cx="876996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ko-KR" sz="1600" spc="-1" strike="noStrike">
                <a:solidFill>
                  <a:srgbClr val="000000"/>
                </a:solidFill>
                <a:latin typeface="Times New Roman"/>
              </a:rPr>
              <a:t>Figure S5  </a:t>
            </a: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L-methionine eliminates the growth rate difference between the wild-type and </a:t>
            </a:r>
            <a:r>
              <a:rPr b="1" lang="ko-KR" sz="1600" spc="-1" strike="noStrike">
                <a:solidFill>
                  <a:srgbClr val="000000"/>
                </a:solidFill>
                <a:latin typeface="Times New Roman"/>
              </a:rPr>
              <a:t>stabilized</a:t>
            </a: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MetAs in Δ</a:t>
            </a:r>
            <a:r>
              <a:rPr b="1" i="1" lang="en-GB" sz="1600" spc="-1" strike="noStrike">
                <a:solidFill>
                  <a:srgbClr val="000000"/>
                </a:solidFill>
                <a:latin typeface="Times New Roman"/>
              </a:rPr>
              <a:t>dnaK </a:t>
            </a: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or protease-deficient mutants at non-permissive temperatures</a:t>
            </a: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굴림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2-08T06:25:22Z</dcterms:created>
  <dc:creator>user</dc:creator>
  <dc:description/>
  <dc:language>en-US</dc:language>
  <cp:lastModifiedBy>user</cp:lastModifiedBy>
  <dcterms:modified xsi:type="dcterms:W3CDTF">2013-06-05T08:45:04Z</dcterms:modified>
  <cp:revision>6</cp:revision>
  <dc:subject/>
  <dc:title>슬라이드 1</dc:title>
</cp:coreProperties>
</file>